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36" y="-4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D04AF3A-CB75-FCCD-B21B-1D73380AFD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74EC295-8C24-1E7D-A0D2-F65FA1E595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36249F6-2A57-0715-7B6F-284100F24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9DA4C4-ADB3-04C1-5DC6-0190F20A9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3F7A7-4622-0D36-CB1B-48C19E03E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1828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6ED69B-4658-A446-F25A-54AC65D36B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B43A694-383A-5AB3-8549-86E8B52722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6EB9C3-188E-C40B-1C61-FEB9F2F85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37C5E1F-0E59-C57A-5D54-3D1973D10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5FC8820-E339-4258-DAF3-D5BA73106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4053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A06A70E-9C39-41C4-20A7-5EE6DC7B8D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0F9B907-34F7-9488-9971-F9E33BA1C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02416C5-E97E-DA16-B2B3-E316121CC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C5E51FD-DF84-EB30-75E9-B77EB350C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9229EAD-A557-2119-2EF4-6E353A1DB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2279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17BBEDE-AAA6-15DD-E2C3-61B6E044D0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92AFDF5-4AA3-5E0C-A111-6ACB3F21F8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C4B749-43FF-3FEA-0897-8A6C94302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AAE3177-4881-0519-3B03-717199B33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A238F97-CC8D-7D7E-CBD4-E46485DC1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9785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CFE1673-9424-9FCE-83D4-876CDF89A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602C33E-59D8-CF88-0F02-1E645E9B47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21ED13-6FD0-13BC-CA7E-5128E14F8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30FE1D4-FA17-FC08-0D8E-3462E6F8B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8DA6A2-D6B8-76FA-350E-9C33A365D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462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3BAEB67-1531-152D-E7F9-2038407FBC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749A5A2-E5FC-2C8C-56CB-04E43FAEEE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185DA62-A1EE-D2DC-3617-D882E4AA80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9700CDA-E93F-C065-5C8B-9131FD572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161C735-F3B5-000E-141C-ABB95FAB5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4CEDBFE-60FA-AB5E-2D38-F794B56E1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4403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0EE288-27EF-4ADD-0680-5C5700956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1B7CA5D-4C1F-8FE2-7F8F-8D5CB8276A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AEE349E-CC64-548A-A07F-EC86627AE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5B7086B-4EF9-4026-1047-2082DE89F5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2A23DE91-FD4A-55D2-D30F-11FFD05BFB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152EDF4-935D-6E51-0664-E80B4F81C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786A414-EBAA-E206-47E1-538168C18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DF1B3C2-7E6D-7B92-9811-102FB1910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8410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AC9419D-E1EB-6531-2486-04AD76776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03849B0-FC5D-EFEA-7C2F-496D4FED2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9CED582-6005-EDE8-B179-EC88CF2BC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70857DE-5A72-D1D8-D930-4A5A3B939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604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6EF9820-6AFB-A7BF-3130-B3B6E0B3E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EB2FBEF-AE9B-6402-7262-89DE6D78B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F8294CB-5EDA-68C7-E7F7-2038FB5E7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991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213864-1A25-5777-50A2-91E0D56C8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A2D1A2C-1781-F135-5CD5-2CFEC24D8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EB2045B-4368-EAD8-64CB-C3E0BAC6A8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3E49552-4031-1CFE-70D9-51DAC2900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B026199-BC2A-3C19-F8E6-4A6BDC34A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5F46AED-A1F0-A5FE-E0B5-FD8FD8CE8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6368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A89E2B8-AA67-7E10-6237-3A8AC2C98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EA70811-FD44-A248-7DDB-6D550D2D50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C90A0FE-0AB7-5AA7-CE4D-775F805C27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F773C03-0679-392C-000F-7A41F2F7B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29E301F-7527-5BF6-7229-8C809D2FA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10B1431-112E-C716-2D2B-3F2A15574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778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7805AEE-C40E-4303-BEF1-298FB782F7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C2F801-1679-076C-8F9E-9A5B8744DE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B1C3687-669A-05D6-7320-4A099C608E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99F1B-57FF-4C03-9DE2-7EC755A1BD79}" type="datetimeFigureOut">
              <a:rPr lang="ko-KR" altLang="en-US" smtClean="0"/>
              <a:t>2025-02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93B763-7F9F-A018-0E51-FD570AEFC3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1DE072-1A19-FE10-B838-0A8842C230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24B39-9DC8-43B3-B82A-683524ECD6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3055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3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73B3F6-A94A-4C48-C55A-2E250E0319EF}"/>
              </a:ext>
            </a:extLst>
          </p:cNvPr>
          <p:cNvSpPr txBox="1"/>
          <p:nvPr/>
        </p:nvSpPr>
        <p:spPr>
          <a:xfrm>
            <a:off x="1508295" y="405353"/>
            <a:ext cx="4004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.1A in vitro DC activation marker</a:t>
            </a:r>
            <a:endParaRPr lang="ko-KR" altLang="en-US" dirty="0"/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296EFB7D-E18F-0F54-E2FF-112A8FF86E59}"/>
              </a:ext>
            </a:extLst>
          </p:cNvPr>
          <p:cNvGrpSpPr/>
          <p:nvPr/>
        </p:nvGrpSpPr>
        <p:grpSpPr>
          <a:xfrm>
            <a:off x="1570752" y="3176030"/>
            <a:ext cx="3567394" cy="383515"/>
            <a:chOff x="708581" y="2801332"/>
            <a:chExt cx="3567394" cy="383515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B9FFFA4-32B5-7809-E1DE-D94211DE39E9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0789CB3-17A1-696C-696A-2C3647714F02}"/>
                </a:ext>
              </a:extLst>
            </p:cNvPr>
            <p:cNvSpPr txBox="1"/>
            <p:nvPr/>
          </p:nvSpPr>
          <p:spPr>
            <a:xfrm>
              <a:off x="1954920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E6959B4-D05E-CD7E-8CDB-FC992542B34B}"/>
                </a:ext>
              </a:extLst>
            </p:cNvPr>
            <p:cNvSpPr txBox="1"/>
            <p:nvPr/>
          </p:nvSpPr>
          <p:spPr>
            <a:xfrm>
              <a:off x="3261595" y="2815515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0ED1107F-A41B-2F73-30C7-1F2B0900773D}"/>
              </a:ext>
            </a:extLst>
          </p:cNvPr>
          <p:cNvSpPr txBox="1"/>
          <p:nvPr/>
        </p:nvSpPr>
        <p:spPr>
          <a:xfrm>
            <a:off x="1508295" y="921558"/>
            <a:ext cx="2254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D40+(%) in BMDC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2DF835-9F62-3D28-2CC2-89CE73572CAD}"/>
              </a:ext>
            </a:extLst>
          </p:cNvPr>
          <p:cNvSpPr txBox="1"/>
          <p:nvPr/>
        </p:nvSpPr>
        <p:spPr>
          <a:xfrm>
            <a:off x="6070596" y="961192"/>
            <a:ext cx="2254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D86+(%) in BMDC</a:t>
            </a:r>
            <a:endParaRPr lang="ko-KR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AD26F4-AA92-06CF-EC8F-E93BB6EBA43A}"/>
              </a:ext>
            </a:extLst>
          </p:cNvPr>
          <p:cNvSpPr txBox="1"/>
          <p:nvPr/>
        </p:nvSpPr>
        <p:spPr>
          <a:xfrm>
            <a:off x="1570752" y="3848163"/>
            <a:ext cx="2339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MHCII+(%) in BMDC</a:t>
            </a:r>
            <a:endParaRPr lang="ko-KR" altLang="en-US" dirty="0"/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84EDCF37-A86B-40F3-388C-3AC7FDA58AA7}"/>
              </a:ext>
            </a:extLst>
          </p:cNvPr>
          <p:cNvGrpSpPr/>
          <p:nvPr/>
        </p:nvGrpSpPr>
        <p:grpSpPr>
          <a:xfrm>
            <a:off x="6860040" y="3171274"/>
            <a:ext cx="3567394" cy="383515"/>
            <a:chOff x="708581" y="2801332"/>
            <a:chExt cx="3567394" cy="383515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FB3BD8B-6CC5-A4CE-D2DF-F500CF0BB5A6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E69DA6E-B3C2-22E4-B896-E740364B6BB9}"/>
                </a:ext>
              </a:extLst>
            </p:cNvPr>
            <p:cNvSpPr txBox="1"/>
            <p:nvPr/>
          </p:nvSpPr>
          <p:spPr>
            <a:xfrm>
              <a:off x="1954920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16C2077-79B8-E142-D69E-9C5BF96C09E0}"/>
                </a:ext>
              </a:extLst>
            </p:cNvPr>
            <p:cNvSpPr txBox="1"/>
            <p:nvPr/>
          </p:nvSpPr>
          <p:spPr>
            <a:xfrm>
              <a:off x="3261595" y="2815515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pic>
        <p:nvPicPr>
          <p:cNvPr id="31" name="그림 30">
            <a:extLst>
              <a:ext uri="{FF2B5EF4-FFF2-40B4-BE49-F238E27FC236}">
                <a16:creationId xmlns:a16="http://schemas.microsoft.com/office/drawing/2014/main" id="{5706B0A3-3D8E-28F6-A836-CB6A3FAF8C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1470" y="1428511"/>
            <a:ext cx="1499716" cy="1458565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5FB2E0F3-E852-1400-98B2-6326A42095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1115" y="1444413"/>
            <a:ext cx="1499717" cy="1458566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A1E08922-053D-79B0-27A3-6BA3C4D35F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7053" y="1438555"/>
            <a:ext cx="1499716" cy="1458565"/>
          </a:xfrm>
          <a:prstGeom prst="rect">
            <a:avLst/>
          </a:prstGeom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2019B5D4-D86E-60F3-C2B2-E30F76FEB1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2100" y="1438555"/>
            <a:ext cx="1499717" cy="1458567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371C7457-07A1-95FD-CD40-AD4517B77C6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37025" y="1438555"/>
            <a:ext cx="1499717" cy="1458567"/>
          </a:xfrm>
          <a:prstGeom prst="rect">
            <a:avLst/>
          </a:prstGeom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id="{E21F340B-2C3E-6AB1-E8F9-076C90313E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99124" y="1438555"/>
            <a:ext cx="1499717" cy="1458567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849A578B-B0CE-DEAB-6753-8CD954F5C68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57262" y="4388295"/>
            <a:ext cx="1499717" cy="1458566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82428BF4-744F-75C0-DE9A-C04EEAF0C82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44197" y="4378868"/>
            <a:ext cx="1499717" cy="1458566"/>
          </a:xfrm>
          <a:prstGeom prst="rect">
            <a:avLst/>
          </a:prstGeom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906783E3-EF57-35AF-2489-BB5375BA7F6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33628" y="4374440"/>
            <a:ext cx="1499717" cy="1458566"/>
          </a:xfrm>
          <a:prstGeom prst="rect">
            <a:avLst/>
          </a:prstGeom>
        </p:spPr>
      </p:pic>
      <p:grpSp>
        <p:nvGrpSpPr>
          <p:cNvPr id="50" name="그룹 49">
            <a:extLst>
              <a:ext uri="{FF2B5EF4-FFF2-40B4-BE49-F238E27FC236}">
                <a16:creationId xmlns:a16="http://schemas.microsoft.com/office/drawing/2014/main" id="{B0CA2A1A-B353-BEFD-F059-803F7C7CE060}"/>
              </a:ext>
            </a:extLst>
          </p:cNvPr>
          <p:cNvGrpSpPr/>
          <p:nvPr/>
        </p:nvGrpSpPr>
        <p:grpSpPr>
          <a:xfrm>
            <a:off x="1540584" y="5936442"/>
            <a:ext cx="3567394" cy="383515"/>
            <a:chOff x="708581" y="2801332"/>
            <a:chExt cx="3567394" cy="383515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ED29931-35EC-716E-2845-889B7B906EE6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F71242F-BC78-3D65-B001-0C888C8B0130}"/>
                </a:ext>
              </a:extLst>
            </p:cNvPr>
            <p:cNvSpPr txBox="1"/>
            <p:nvPr/>
          </p:nvSpPr>
          <p:spPr>
            <a:xfrm>
              <a:off x="1954920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2D32F96-301A-0D3E-F7F9-AF623F33D0E5}"/>
                </a:ext>
              </a:extLst>
            </p:cNvPr>
            <p:cNvSpPr txBox="1"/>
            <p:nvPr/>
          </p:nvSpPr>
          <p:spPr>
            <a:xfrm>
              <a:off x="3261595" y="2815515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98960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8C8832-3C1A-56EE-2C9A-221E23471E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>
            <a:extLst>
              <a:ext uri="{FF2B5EF4-FFF2-40B4-BE49-F238E27FC236}">
                <a16:creationId xmlns:a16="http://schemas.microsoft.com/office/drawing/2014/main" id="{07F9E280-F0B6-8811-6AC2-CA4A0F72AA11}"/>
              </a:ext>
            </a:extLst>
          </p:cNvPr>
          <p:cNvGrpSpPr/>
          <p:nvPr/>
        </p:nvGrpSpPr>
        <p:grpSpPr>
          <a:xfrm>
            <a:off x="6274720" y="6160151"/>
            <a:ext cx="4433855" cy="396193"/>
            <a:chOff x="708581" y="2774471"/>
            <a:chExt cx="4433855" cy="396193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4D160F5-2981-863A-4C73-08C09B13C1E6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664458D-7187-0B4A-A916-6D24B0436A13}"/>
                </a:ext>
              </a:extLst>
            </p:cNvPr>
            <p:cNvSpPr txBox="1"/>
            <p:nvPr/>
          </p:nvSpPr>
          <p:spPr>
            <a:xfrm>
              <a:off x="2461944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006459D-94A7-12C7-CC6E-D0507F969355}"/>
                </a:ext>
              </a:extLst>
            </p:cNvPr>
            <p:cNvSpPr txBox="1"/>
            <p:nvPr/>
          </p:nvSpPr>
          <p:spPr>
            <a:xfrm>
              <a:off x="4128056" y="2774471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EF741273-532D-D47E-5338-276A5F2F4E64}"/>
              </a:ext>
            </a:extLst>
          </p:cNvPr>
          <p:cNvSpPr txBox="1"/>
          <p:nvPr/>
        </p:nvSpPr>
        <p:spPr>
          <a:xfrm>
            <a:off x="6221695" y="3781704"/>
            <a:ext cx="3741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MHCII+(%) in CD206-F4/80+ cells</a:t>
            </a:r>
            <a:endParaRPr lang="ko-KR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1E1B5E-6985-4FD8-9E1B-49DDF04CC2BA}"/>
              </a:ext>
            </a:extLst>
          </p:cNvPr>
          <p:cNvSpPr txBox="1"/>
          <p:nvPr/>
        </p:nvSpPr>
        <p:spPr>
          <a:xfrm>
            <a:off x="1508295" y="405353"/>
            <a:ext cx="4996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.2A in vitro macrophage activation marker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4A47C11F-1217-AEAC-0DFC-E129CC2034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7744" y="4292445"/>
            <a:ext cx="1638021" cy="162276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C60B2685-70DF-C848-A5B5-D2D45B00EF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5140" y="4292445"/>
            <a:ext cx="1638021" cy="162276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FAAF85C7-E7A0-AB8B-5A66-91542A0B51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41965" y="4292445"/>
            <a:ext cx="1638021" cy="162276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7DE49F32-3EB6-A119-F863-C4349960F7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25771" y="1451789"/>
            <a:ext cx="1604131" cy="1589186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542D7605-C275-7A21-748C-9C27792474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63792" y="1506450"/>
            <a:ext cx="1604131" cy="1589186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915E43BB-8AB0-1266-EE9D-4F1CFEC93D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26936" y="1506450"/>
            <a:ext cx="1604131" cy="158918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7F8408B0-D5FF-4FD6-D48C-FDAFDA2C42AD}"/>
              </a:ext>
            </a:extLst>
          </p:cNvPr>
          <p:cNvSpPr txBox="1"/>
          <p:nvPr/>
        </p:nvSpPr>
        <p:spPr>
          <a:xfrm>
            <a:off x="6111607" y="951772"/>
            <a:ext cx="365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D40+(%) in CD206-F4/80+ cells</a:t>
            </a:r>
            <a:endParaRPr lang="ko-KR" altLang="en-US" dirty="0"/>
          </a:p>
        </p:txBody>
      </p:sp>
      <p:pic>
        <p:nvPicPr>
          <p:cNvPr id="33" name="그림 32">
            <a:extLst>
              <a:ext uri="{FF2B5EF4-FFF2-40B4-BE49-F238E27FC236}">
                <a16:creationId xmlns:a16="http://schemas.microsoft.com/office/drawing/2014/main" id="{D232DE00-9989-E4D0-89B0-ADE6B154711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98592" y="1497297"/>
            <a:ext cx="1604131" cy="1589186"/>
          </a:xfrm>
          <a:prstGeom prst="rect">
            <a:avLst/>
          </a:prstGeom>
        </p:spPr>
      </p:pic>
      <p:pic>
        <p:nvPicPr>
          <p:cNvPr id="34" name="그림 33">
            <a:extLst>
              <a:ext uri="{FF2B5EF4-FFF2-40B4-BE49-F238E27FC236}">
                <a16:creationId xmlns:a16="http://schemas.microsoft.com/office/drawing/2014/main" id="{BB503BBE-236C-B899-6B12-B730296EF3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5754" y="1529538"/>
            <a:ext cx="1604131" cy="1589186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67273107-E467-D808-3265-C18E8881AEF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22618" y="1467628"/>
            <a:ext cx="1604131" cy="1589186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B6642488-5271-1214-1AF1-8AA8FDB3275B}"/>
              </a:ext>
            </a:extLst>
          </p:cNvPr>
          <p:cNvSpPr txBox="1"/>
          <p:nvPr/>
        </p:nvSpPr>
        <p:spPr>
          <a:xfrm>
            <a:off x="843595" y="1045595"/>
            <a:ext cx="2997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D206+(%) in F4/80+ cells</a:t>
            </a:r>
            <a:endParaRPr lang="ko-KR" altLang="en-US" dirty="0"/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95B6DB5A-447C-7C47-F6FD-A30008C96507}"/>
              </a:ext>
            </a:extLst>
          </p:cNvPr>
          <p:cNvGrpSpPr/>
          <p:nvPr/>
        </p:nvGrpSpPr>
        <p:grpSpPr>
          <a:xfrm>
            <a:off x="843595" y="3240460"/>
            <a:ext cx="4433855" cy="396193"/>
            <a:chOff x="708581" y="2774471"/>
            <a:chExt cx="4433855" cy="396193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259048A-EB20-3AE0-E488-47CE68C021BB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1170BF8-CBF9-EDFC-371F-E7A478CEA0E7}"/>
                </a:ext>
              </a:extLst>
            </p:cNvPr>
            <p:cNvSpPr txBox="1"/>
            <p:nvPr/>
          </p:nvSpPr>
          <p:spPr>
            <a:xfrm>
              <a:off x="2461944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4C0F0FB-CE0E-F15F-457C-ECB8C8960C66}"/>
                </a:ext>
              </a:extLst>
            </p:cNvPr>
            <p:cNvSpPr txBox="1"/>
            <p:nvPr/>
          </p:nvSpPr>
          <p:spPr>
            <a:xfrm>
              <a:off x="4128056" y="2774471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94B14724-6072-A333-DB14-F89F6BE856BC}"/>
              </a:ext>
            </a:extLst>
          </p:cNvPr>
          <p:cNvGrpSpPr/>
          <p:nvPr/>
        </p:nvGrpSpPr>
        <p:grpSpPr>
          <a:xfrm>
            <a:off x="6186372" y="3212210"/>
            <a:ext cx="4433855" cy="396193"/>
            <a:chOff x="708581" y="2774471"/>
            <a:chExt cx="4433855" cy="396193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C45C57A-96D1-00B8-80B8-BFF77EE4A4C5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905BABE-154E-4DC9-EA27-0FB4BEA721B6}"/>
                </a:ext>
              </a:extLst>
            </p:cNvPr>
            <p:cNvSpPr txBox="1"/>
            <p:nvPr/>
          </p:nvSpPr>
          <p:spPr>
            <a:xfrm>
              <a:off x="2461944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C03A9D0-5D21-F24A-1326-82941D5C7689}"/>
                </a:ext>
              </a:extLst>
            </p:cNvPr>
            <p:cNvSpPr txBox="1"/>
            <p:nvPr/>
          </p:nvSpPr>
          <p:spPr>
            <a:xfrm>
              <a:off x="4128056" y="2774471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CE4ED4D3-6688-F58A-9F11-00382909ED7D}"/>
              </a:ext>
            </a:extLst>
          </p:cNvPr>
          <p:cNvSpPr txBox="1"/>
          <p:nvPr/>
        </p:nvSpPr>
        <p:spPr>
          <a:xfrm>
            <a:off x="846964" y="3813971"/>
            <a:ext cx="365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D40+(%) in CD206-F4/80+ cells</a:t>
            </a:r>
            <a:endParaRPr lang="ko-KR" altLang="en-US" dirty="0"/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4575EA69-E3BC-256B-BDFA-094B83373346}"/>
              </a:ext>
            </a:extLst>
          </p:cNvPr>
          <p:cNvGrpSpPr/>
          <p:nvPr/>
        </p:nvGrpSpPr>
        <p:grpSpPr>
          <a:xfrm>
            <a:off x="783729" y="6154392"/>
            <a:ext cx="4433855" cy="396193"/>
            <a:chOff x="708581" y="2774471"/>
            <a:chExt cx="4433855" cy="39619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95EF998-ECA0-47E9-374F-0AEEFBF82367}"/>
                </a:ext>
              </a:extLst>
            </p:cNvPr>
            <p:cNvSpPr txBox="1"/>
            <p:nvPr/>
          </p:nvSpPr>
          <p:spPr>
            <a:xfrm>
              <a:off x="708581" y="2801332"/>
              <a:ext cx="954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Control</a:t>
              </a:r>
              <a:endParaRPr lang="ko-KR" alt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3D9652F-2495-4827-2BCB-122894708BDB}"/>
                </a:ext>
              </a:extLst>
            </p:cNvPr>
            <p:cNvSpPr txBox="1"/>
            <p:nvPr/>
          </p:nvSpPr>
          <p:spPr>
            <a:xfrm>
              <a:off x="2461944" y="2801332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6</a:t>
              </a:r>
              <a:endParaRPr lang="ko-KR" alt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B1014DA-1BD6-EB7F-76D6-6FC96A5AB46B}"/>
                </a:ext>
              </a:extLst>
            </p:cNvPr>
            <p:cNvSpPr txBox="1"/>
            <p:nvPr/>
          </p:nvSpPr>
          <p:spPr>
            <a:xfrm>
              <a:off x="4128056" y="2774471"/>
              <a:ext cx="10143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LJ 10^7</a:t>
              </a:r>
              <a:endParaRPr lang="ko-KR" altLang="en-US" dirty="0"/>
            </a:p>
          </p:txBody>
        </p:sp>
      </p:grpSp>
      <p:pic>
        <p:nvPicPr>
          <p:cNvPr id="27" name="그림 26">
            <a:extLst>
              <a:ext uri="{FF2B5EF4-FFF2-40B4-BE49-F238E27FC236}">
                <a16:creationId xmlns:a16="http://schemas.microsoft.com/office/drawing/2014/main" id="{D07A0231-735E-0035-0CA2-7F93CF1EF2C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70852" y="4304465"/>
            <a:ext cx="1638021" cy="1622760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778A5650-6C45-1833-BA9E-CC71F4FCDE9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183456" y="4298414"/>
            <a:ext cx="1638021" cy="1622760"/>
          </a:xfrm>
          <a:prstGeom prst="rect">
            <a:avLst/>
          </a:prstGeom>
        </p:spPr>
      </p:pic>
      <p:pic>
        <p:nvPicPr>
          <p:cNvPr id="45" name="그림 44">
            <a:extLst>
              <a:ext uri="{FF2B5EF4-FFF2-40B4-BE49-F238E27FC236}">
                <a16:creationId xmlns:a16="http://schemas.microsoft.com/office/drawing/2014/main" id="{A9AB21F6-78CB-6C43-2FE5-E23C8741D06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5961" y="4280197"/>
            <a:ext cx="1638021" cy="1622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4832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EEEA29B-B2D8-6E89-EDE8-B6519598CBA7}"/>
              </a:ext>
            </a:extLst>
          </p:cNvPr>
          <p:cNvSpPr txBox="1"/>
          <p:nvPr/>
        </p:nvSpPr>
        <p:spPr>
          <a:xfrm>
            <a:off x="660728" y="3229672"/>
            <a:ext cx="954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ontrol</a:t>
            </a:r>
            <a:endParaRPr lang="ko-KR" alt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D19969E-749C-5005-F767-D8A1C3582E1C}"/>
              </a:ext>
            </a:extLst>
          </p:cNvPr>
          <p:cNvSpPr txBox="1"/>
          <p:nvPr/>
        </p:nvSpPr>
        <p:spPr>
          <a:xfrm>
            <a:off x="2869608" y="3284099"/>
            <a:ext cx="390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LJ</a:t>
            </a:r>
            <a:endParaRPr lang="ko-KR" alt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00D3BE-E614-0B77-4426-0AA70E96673E}"/>
              </a:ext>
            </a:extLst>
          </p:cNvPr>
          <p:cNvSpPr txBox="1"/>
          <p:nvPr/>
        </p:nvSpPr>
        <p:spPr>
          <a:xfrm>
            <a:off x="397096" y="580876"/>
            <a:ext cx="32351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/>
              <a:t>Fig.4A LPM and SPM (%) in </a:t>
            </a:r>
          </a:p>
          <a:p>
            <a:pPr algn="ctr"/>
            <a:r>
              <a:rPr lang="en-US" altLang="ko-KR" dirty="0"/>
              <a:t>peritoneal macrophage</a:t>
            </a:r>
            <a:endParaRPr lang="ko-KR" altLang="en-US" dirty="0"/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34376584-8725-2733-E60A-1D5C3F2700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908" y="1440522"/>
            <a:ext cx="1677828" cy="1662196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C3D9F64B-0BF2-ADB7-E099-D9D1CCC61B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0002" y="1473180"/>
            <a:ext cx="1677828" cy="1662196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57B57AA7-1C55-C97D-CC9D-1CE6BE97E3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82521" y="4593312"/>
            <a:ext cx="1310668" cy="1298457"/>
          </a:xfrm>
          <a:prstGeom prst="rect">
            <a:avLst/>
          </a:prstGeom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931EB9A3-2A55-754A-6821-9AB91974D5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56605" y="4615084"/>
            <a:ext cx="1310667" cy="1298456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C771464-845D-B79C-248E-7C3CF2EE773B}"/>
              </a:ext>
            </a:extLst>
          </p:cNvPr>
          <p:cNvSpPr txBox="1"/>
          <p:nvPr/>
        </p:nvSpPr>
        <p:spPr>
          <a:xfrm>
            <a:off x="1880562" y="6165992"/>
            <a:ext cx="1301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FN-r FMO</a:t>
            </a:r>
            <a:endParaRPr lang="ko-KR" alt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2099097-0FB4-FFC3-23CB-B60108C46E3F}"/>
              </a:ext>
            </a:extLst>
          </p:cNvPr>
          <p:cNvSpPr txBox="1"/>
          <p:nvPr/>
        </p:nvSpPr>
        <p:spPr>
          <a:xfrm>
            <a:off x="3182521" y="6165992"/>
            <a:ext cx="1327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L-4+ FMO</a:t>
            </a:r>
            <a:endParaRPr lang="ko-KR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26F267-C087-68BB-B43F-CFF10A635C38}"/>
              </a:ext>
            </a:extLst>
          </p:cNvPr>
          <p:cNvSpPr txBox="1"/>
          <p:nvPr/>
        </p:nvSpPr>
        <p:spPr>
          <a:xfrm>
            <a:off x="4971954" y="546865"/>
            <a:ext cx="69318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. 5A, B Intracellular cytokine producing T cell in Peyer’s patch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8EB26D-3CA7-5B3B-2053-F308A1849AAF}"/>
              </a:ext>
            </a:extLst>
          </p:cNvPr>
          <p:cNvSpPr txBox="1"/>
          <p:nvPr/>
        </p:nvSpPr>
        <p:spPr>
          <a:xfrm>
            <a:off x="5100400" y="3392956"/>
            <a:ext cx="954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ontrol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AFA7636-5246-5FE4-A3BA-D659E252313D}"/>
              </a:ext>
            </a:extLst>
          </p:cNvPr>
          <p:cNvSpPr txBox="1"/>
          <p:nvPr/>
        </p:nvSpPr>
        <p:spPr>
          <a:xfrm>
            <a:off x="7145996" y="3392956"/>
            <a:ext cx="390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LJ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710BB28-1045-BB93-C153-194C9CF73FC0}"/>
              </a:ext>
            </a:extLst>
          </p:cNvPr>
          <p:cNvSpPr txBox="1"/>
          <p:nvPr/>
        </p:nvSpPr>
        <p:spPr>
          <a:xfrm>
            <a:off x="4971954" y="1129057"/>
            <a:ext cx="2632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FN-r+(%) in CD4 T cell</a:t>
            </a:r>
            <a:endParaRPr lang="ko-KR" altLang="en-US" dirty="0"/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B2D4CAA8-A40E-B303-92A3-D4356240A2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05662" y="1730760"/>
            <a:ext cx="1677828" cy="1662196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7686EF42-267A-4057-2155-FEED2AFE012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83530" y="1730760"/>
            <a:ext cx="1677828" cy="1662196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BC5049C0-653F-9E48-F016-8BF4DE85F90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633289" y="1730760"/>
            <a:ext cx="1677828" cy="1662196"/>
          </a:xfrm>
          <a:prstGeom prst="rect">
            <a:avLst/>
          </a:prstGeom>
        </p:spPr>
      </p:pic>
      <p:pic>
        <p:nvPicPr>
          <p:cNvPr id="27" name="그림 26">
            <a:extLst>
              <a:ext uri="{FF2B5EF4-FFF2-40B4-BE49-F238E27FC236}">
                <a16:creationId xmlns:a16="http://schemas.microsoft.com/office/drawing/2014/main" id="{1E6A2D7E-6AAB-27D4-D3C9-F80A5800F5A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408432" y="1730760"/>
            <a:ext cx="1677828" cy="1662196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D7EC3CE-09B5-7631-20A7-07B6D31D824C}"/>
              </a:ext>
            </a:extLst>
          </p:cNvPr>
          <p:cNvSpPr txBox="1"/>
          <p:nvPr/>
        </p:nvSpPr>
        <p:spPr>
          <a:xfrm>
            <a:off x="9175042" y="3392956"/>
            <a:ext cx="954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ontrol</a:t>
            </a:r>
            <a:endParaRPr lang="ko-KR" alt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CB10664-5737-2445-F959-D57AA657E14A}"/>
              </a:ext>
            </a:extLst>
          </p:cNvPr>
          <p:cNvSpPr txBox="1"/>
          <p:nvPr/>
        </p:nvSpPr>
        <p:spPr>
          <a:xfrm>
            <a:off x="11220638" y="3392956"/>
            <a:ext cx="390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LJ</a:t>
            </a:r>
            <a:endParaRPr lang="ko-KR" alt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148AF40-B05B-C1A5-1C9E-E87A029E6FD2}"/>
              </a:ext>
            </a:extLst>
          </p:cNvPr>
          <p:cNvSpPr txBox="1"/>
          <p:nvPr/>
        </p:nvSpPr>
        <p:spPr>
          <a:xfrm>
            <a:off x="8895076" y="1129057"/>
            <a:ext cx="2577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L-4+(%) in  CD4 T cell</a:t>
            </a:r>
            <a:endParaRPr lang="ko-KR" altLang="en-US" dirty="0"/>
          </a:p>
        </p:txBody>
      </p:sp>
      <p:pic>
        <p:nvPicPr>
          <p:cNvPr id="31" name="그림 30">
            <a:extLst>
              <a:ext uri="{FF2B5EF4-FFF2-40B4-BE49-F238E27FC236}">
                <a16:creationId xmlns:a16="http://schemas.microsoft.com/office/drawing/2014/main" id="{CFB69E41-12AF-BABF-58EE-95B1C810EA4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61358" y="4276000"/>
            <a:ext cx="1677829" cy="1662197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6EE50117-7CBC-F5B1-5DAB-20D78132E07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10336" y="4276000"/>
            <a:ext cx="1677829" cy="166219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8CAB9A5F-F0ED-B523-D173-E58F787DEA06}"/>
              </a:ext>
            </a:extLst>
          </p:cNvPr>
          <p:cNvSpPr txBox="1"/>
          <p:nvPr/>
        </p:nvSpPr>
        <p:spPr>
          <a:xfrm>
            <a:off x="4898107" y="3807844"/>
            <a:ext cx="2714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FN-r+(%) in  CD8 T cell</a:t>
            </a:r>
            <a:endParaRPr lang="ko-KR" alt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8727A9-ED19-BDC0-6593-EB01D9C29A55}"/>
              </a:ext>
            </a:extLst>
          </p:cNvPr>
          <p:cNvSpPr txBox="1"/>
          <p:nvPr/>
        </p:nvSpPr>
        <p:spPr>
          <a:xfrm>
            <a:off x="5096680" y="6059952"/>
            <a:ext cx="954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ontrol</a:t>
            </a:r>
            <a:endParaRPr lang="ko-KR" alt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E24B25E-3CFA-D6B9-C360-4F494568E623}"/>
              </a:ext>
            </a:extLst>
          </p:cNvPr>
          <p:cNvSpPr txBox="1"/>
          <p:nvPr/>
        </p:nvSpPr>
        <p:spPr>
          <a:xfrm>
            <a:off x="7142276" y="6059952"/>
            <a:ext cx="390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LJ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DC11C1-655F-F666-32EF-1FC78D54C6EA}"/>
              </a:ext>
            </a:extLst>
          </p:cNvPr>
          <p:cNvSpPr txBox="1"/>
          <p:nvPr/>
        </p:nvSpPr>
        <p:spPr>
          <a:xfrm>
            <a:off x="8819613" y="3820849"/>
            <a:ext cx="2577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IL-4+(%) in  CD8 T cell</a:t>
            </a:r>
            <a:endParaRPr lang="ko-KR" alt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7EA1839-950D-0F5A-7A0B-6B0CE21A24BC}"/>
              </a:ext>
            </a:extLst>
          </p:cNvPr>
          <p:cNvSpPr txBox="1"/>
          <p:nvPr/>
        </p:nvSpPr>
        <p:spPr>
          <a:xfrm>
            <a:off x="9018186" y="6072957"/>
            <a:ext cx="954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Control</a:t>
            </a:r>
            <a:endParaRPr lang="ko-KR" alt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15B9C64-F104-F9FD-721D-8CCA55005555}"/>
              </a:ext>
            </a:extLst>
          </p:cNvPr>
          <p:cNvSpPr txBox="1"/>
          <p:nvPr/>
        </p:nvSpPr>
        <p:spPr>
          <a:xfrm>
            <a:off x="11063782" y="6072957"/>
            <a:ext cx="390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LJ</a:t>
            </a:r>
            <a:endParaRPr lang="ko-KR" altLang="en-US" dirty="0"/>
          </a:p>
        </p:txBody>
      </p:sp>
      <p:pic>
        <p:nvPicPr>
          <p:cNvPr id="42" name="그림 41">
            <a:extLst>
              <a:ext uri="{FF2B5EF4-FFF2-40B4-BE49-F238E27FC236}">
                <a16:creationId xmlns:a16="http://schemas.microsoft.com/office/drawing/2014/main" id="{E793DFD6-F860-F5E9-33E9-66C426B527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429273" y="4370497"/>
            <a:ext cx="1705343" cy="1689455"/>
          </a:xfrm>
          <a:prstGeom prst="rect">
            <a:avLst/>
          </a:prstGeom>
        </p:spPr>
      </p:pic>
      <p:pic>
        <p:nvPicPr>
          <p:cNvPr id="43" name="그림 42">
            <a:extLst>
              <a:ext uri="{FF2B5EF4-FFF2-40B4-BE49-F238E27FC236}">
                <a16:creationId xmlns:a16="http://schemas.microsoft.com/office/drawing/2014/main" id="{DCEEEA5E-EA93-B455-A5CF-9D8837E28F9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41716" y="4303237"/>
            <a:ext cx="1705343" cy="1689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041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6</TotalTime>
  <Words>149</Words>
  <Application>Microsoft Office PowerPoint</Application>
  <PresentationFormat>와이드스크린</PresentationFormat>
  <Paragraphs>49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소연 안</dc:creator>
  <cp:lastModifiedBy>소연 안</cp:lastModifiedBy>
  <cp:revision>9</cp:revision>
  <dcterms:created xsi:type="dcterms:W3CDTF">2025-02-21T00:49:29Z</dcterms:created>
  <dcterms:modified xsi:type="dcterms:W3CDTF">2025-02-24T08:01:52Z</dcterms:modified>
</cp:coreProperties>
</file>